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06C14-4269-4CDE-B30D-925C441FD1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87B71-86FC-4B7A-A67E-EFB851CF85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69767-AD4C-4361-990D-56E4CA24EB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AFEC4-D749-417E-822D-A6C99A02D2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1F7565-3321-4578-B3A6-826B008E64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8C6AA2-417F-4F59-B260-55E294EFDE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5D97F1-40CF-4E4B-8505-9EEB3A06B6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78347-9726-4C4D-8317-2DDB2394CE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A1143E-52BF-4CD2-A613-EE7008E3C4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A5DD4A-40FC-4D26-842B-191358EBE3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83201-02CE-4B39-AAF1-3ED5BFD3B7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82ED2C-8DAC-4ED5-92DA-7CC3829EC6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832924-EE41-46B1-844F-082006217B5E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635280" y="1773360"/>
          <a:ext cx="1584360" cy="1584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635280" y="1773360"/>
                    <a:ext cx="1584360" cy="1584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 rot="16200000">
            <a:off x="3575520" y="1349280"/>
            <a:ext cx="57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LD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6200000">
            <a:off x="3937680" y="135720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T2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4300920" y="1365480"/>
            <a:ext cx="53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LoV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6200000">
            <a:off x="4584960" y="129312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W4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7" name=""/>
          <p:cNvGraphicFramePr/>
          <p:nvPr/>
        </p:nvGraphicFramePr>
        <p:xfrm>
          <a:off x="3635280" y="3429000"/>
          <a:ext cx="1584360" cy="4316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635280" y="3429000"/>
                    <a:ext cx="1584360" cy="4316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49" name=""/>
          <p:cNvSpPr/>
          <p:nvPr/>
        </p:nvSpPr>
        <p:spPr>
          <a:xfrm>
            <a:off x="1600200" y="4818240"/>
            <a:ext cx="54198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Figure S3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iton-X100 and hypotonic cell lysates derived fro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same numbers of DLD1, HT29, LoVo and SW480 cells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were submit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to western blotting using anti-APC and anti-</a:t>
            </a:r>
            <a:r>
              <a:rPr b="0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-catenin antibodies, respectivel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292360" y="2865600"/>
            <a:ext cx="49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291280" y="3514680"/>
            <a:ext cx="93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2200" y="43560"/>
            <a:ext cx="164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Vijaya Chandra et al.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4T12:41:56Z</dcterms:created>
  <dc:creator>jschneik</dc:creator>
  <dc:description/>
  <dc:language>en-US</dc:language>
  <cp:lastModifiedBy>jschneik</cp:lastModifiedBy>
  <dcterms:modified xsi:type="dcterms:W3CDTF">2012-03-12T10:28:08Z</dcterms:modified>
  <cp:revision>47</cp:revision>
  <dc:subject/>
  <dc:title>Folie 1</dc:title>
</cp:coreProperties>
</file>